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74" r:id="rId2"/>
    <p:sldId id="276" r:id="rId3"/>
    <p:sldId id="275" r:id="rId4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royuki Sasaki" initials="H.S." lastIdx="1" clrIdx="0">
    <p:extLst>
      <p:ext uri="{19B8F6BF-5375-455C-9EA6-DF929625EA0E}">
        <p15:presenceInfo xmlns:p15="http://schemas.microsoft.com/office/powerpoint/2012/main" userId="Hiroyuki Sasak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0000"/>
    <a:srgbClr val="FC00F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09" autoAdjust="0"/>
    <p:restoredTop sz="94578" autoAdjust="0"/>
  </p:normalViewPr>
  <p:slideViewPr>
    <p:cSldViewPr snapToGrid="0">
      <p:cViewPr>
        <p:scale>
          <a:sx n="150" d="100"/>
          <a:sy n="150" d="100"/>
        </p:scale>
        <p:origin x="1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21271;&#28023;&#36947;&#24773;&#22577;&#22823;&#23398;&#33144;&#20869;&#32048;&#33740;\&#12499;&#12483;&#12464;&#12487;&#12540;&#12479;&#35299;&#26512;\2019Summer\2019SummerMicrobeNouhaFood-&#33075;&#27874;&#12513;&#12452;&#12531;&#35299;&#2651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21271;&#28023;&#36947;&#24773;&#22577;&#22823;&#23398;&#33144;&#20869;&#32048;&#33740;\&#12499;&#12483;&#12464;&#12487;&#12540;&#12479;&#35299;&#26512;\2019Summer\2019SummerMicrobeNouhaFood-&#33075;&#27874;&#12513;&#12452;&#12531;&#35299;&#2651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21271;&#28023;&#36947;&#24773;&#22577;&#22823;&#23398;&#33144;&#20869;&#32048;&#33740;\&#12499;&#12483;&#12464;&#12487;&#12540;&#12479;&#35299;&#26512;\2019Summer\2019SummerMicrobeNouhaFood-&#33075;&#27874;&#12513;&#12452;&#12531;&#35299;&#26512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ヒストグラム作成!$C$3:$C$8</c:f>
              <c:numCache>
                <c:formatCode>General</c:formatCode>
                <c:ptCount val="6"/>
                <c:pt idx="0">
                  <c:v>29</c:v>
                </c:pt>
                <c:pt idx="1">
                  <c:v>39</c:v>
                </c:pt>
                <c:pt idx="2">
                  <c:v>49</c:v>
                </c:pt>
                <c:pt idx="3">
                  <c:v>59</c:v>
                </c:pt>
                <c:pt idx="4">
                  <c:v>69</c:v>
                </c:pt>
                <c:pt idx="5">
                  <c:v>79</c:v>
                </c:pt>
              </c:numCache>
            </c:numRef>
          </c:cat>
          <c:val>
            <c:numRef>
              <c:f>ヒストグラム作成!$D$3:$D$8</c:f>
              <c:numCache>
                <c:formatCode>General</c:formatCode>
                <c:ptCount val="6"/>
                <c:pt idx="0">
                  <c:v>30</c:v>
                </c:pt>
                <c:pt idx="1">
                  <c:v>82</c:v>
                </c:pt>
                <c:pt idx="2">
                  <c:v>154</c:v>
                </c:pt>
                <c:pt idx="3">
                  <c:v>188</c:v>
                </c:pt>
                <c:pt idx="4">
                  <c:v>112</c:v>
                </c:pt>
                <c:pt idx="5">
                  <c:v>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23D-454D-B445-56AAE3C16D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677167704"/>
        <c:axId val="677166392"/>
      </c:barChart>
      <c:catAx>
        <c:axId val="677167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7166392"/>
        <c:crosses val="autoZero"/>
        <c:auto val="1"/>
        <c:lblAlgn val="ctr"/>
        <c:lblOffset val="100"/>
        <c:noMultiLvlLbl val="0"/>
      </c:catAx>
      <c:valAx>
        <c:axId val="6771663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7167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 baseline="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ヒストグラム作成!$I$3:$I$8</c:f>
              <c:numCache>
                <c:formatCode>General</c:formatCode>
                <c:ptCount val="6"/>
                <c:pt idx="0">
                  <c:v>29</c:v>
                </c:pt>
                <c:pt idx="1">
                  <c:v>39</c:v>
                </c:pt>
                <c:pt idx="2">
                  <c:v>49</c:v>
                </c:pt>
                <c:pt idx="3">
                  <c:v>59</c:v>
                </c:pt>
                <c:pt idx="4">
                  <c:v>69</c:v>
                </c:pt>
                <c:pt idx="5">
                  <c:v>79</c:v>
                </c:pt>
              </c:numCache>
            </c:numRef>
          </c:cat>
          <c:val>
            <c:numRef>
              <c:f>ヒストグラム作成!$J$3:$J$8</c:f>
              <c:numCache>
                <c:formatCode>General</c:formatCode>
                <c:ptCount val="6"/>
                <c:pt idx="0">
                  <c:v>11</c:v>
                </c:pt>
                <c:pt idx="1">
                  <c:v>27</c:v>
                </c:pt>
                <c:pt idx="2">
                  <c:v>47</c:v>
                </c:pt>
                <c:pt idx="3">
                  <c:v>49</c:v>
                </c:pt>
                <c:pt idx="4">
                  <c:v>45</c:v>
                </c:pt>
                <c:pt idx="5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348-4889-A1D7-60C5AB0ED3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677168032"/>
        <c:axId val="677162784"/>
      </c:barChart>
      <c:catAx>
        <c:axId val="677168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7162784"/>
        <c:crosses val="autoZero"/>
        <c:auto val="1"/>
        <c:lblAlgn val="ctr"/>
        <c:lblOffset val="100"/>
        <c:noMultiLvlLbl val="0"/>
      </c:catAx>
      <c:valAx>
        <c:axId val="677162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7168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 baseline="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ヒストグラム作成!$O$3:$O$8</c:f>
              <c:numCache>
                <c:formatCode>General</c:formatCode>
                <c:ptCount val="6"/>
                <c:pt idx="0">
                  <c:v>29</c:v>
                </c:pt>
                <c:pt idx="1">
                  <c:v>39</c:v>
                </c:pt>
                <c:pt idx="2">
                  <c:v>49</c:v>
                </c:pt>
                <c:pt idx="3">
                  <c:v>59</c:v>
                </c:pt>
                <c:pt idx="4">
                  <c:v>69</c:v>
                </c:pt>
                <c:pt idx="5">
                  <c:v>79</c:v>
                </c:pt>
              </c:numCache>
            </c:numRef>
          </c:cat>
          <c:val>
            <c:numRef>
              <c:f>ヒストグラム作成!$P$3:$P$8</c:f>
              <c:numCache>
                <c:formatCode>General</c:formatCode>
                <c:ptCount val="6"/>
                <c:pt idx="0">
                  <c:v>19</c:v>
                </c:pt>
                <c:pt idx="1">
                  <c:v>55</c:v>
                </c:pt>
                <c:pt idx="2">
                  <c:v>107</c:v>
                </c:pt>
                <c:pt idx="3">
                  <c:v>139</c:v>
                </c:pt>
                <c:pt idx="4">
                  <c:v>67</c:v>
                </c:pt>
                <c:pt idx="5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7D-4EC9-995D-30C4B2DC9B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677209032"/>
        <c:axId val="677210344"/>
      </c:barChart>
      <c:catAx>
        <c:axId val="677209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7210344"/>
        <c:crosses val="autoZero"/>
        <c:auto val="1"/>
        <c:lblAlgn val="ctr"/>
        <c:lblOffset val="100"/>
        <c:noMultiLvlLbl val="0"/>
      </c:catAx>
      <c:valAx>
        <c:axId val="677210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7209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 baseline="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909260-4C06-4AFE-AFD1-FA47943E24FC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FE1247-8D11-42A8-B7F9-8C9D1EDC80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51692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8762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480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718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382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9814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842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84053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1418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7994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266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788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C532E-AAF0-4717-AB44-C5BB3BE04835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294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447763" y="8887139"/>
            <a:ext cx="1410237" cy="2568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pPr algn="ctr"/>
            <a:r>
              <a:rPr lang="en-US" altLang="ja-JP" sz="1069" dirty="0" smtClean="0"/>
              <a:t>Supplemental Fig.1</a:t>
            </a:r>
            <a:endParaRPr lang="ja-JP" altLang="en-US" sz="1069" dirty="0"/>
          </a:p>
        </p:txBody>
      </p:sp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4270273"/>
              </p:ext>
            </p:extLst>
          </p:nvPr>
        </p:nvGraphicFramePr>
        <p:xfrm>
          <a:off x="1163818" y="150254"/>
          <a:ext cx="4626949" cy="36490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626949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36490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set from the</a:t>
                      </a:r>
                      <a:r>
                        <a:rPr kumimoji="1" lang="en-US" altLang="ja-JP" sz="14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“</a:t>
                      </a:r>
                      <a:r>
                        <a:rPr kumimoji="1" lang="en-US" altLang="ja-JP" sz="1400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koyaka</a:t>
                      </a:r>
                      <a:r>
                        <a:rPr kumimoji="1" lang="en-US" altLang="ja-JP" sz="14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ealth Survey” (n=642)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</a:tbl>
          </a:graphicData>
        </a:graphic>
      </p:graphicFrame>
      <p:graphicFrame>
        <p:nvGraphicFramePr>
          <p:cNvPr id="19" name="表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5519710"/>
              </p:ext>
            </p:extLst>
          </p:nvPr>
        </p:nvGraphicFramePr>
        <p:xfrm>
          <a:off x="3889248" y="757403"/>
          <a:ext cx="2852928" cy="100498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52928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36490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luded (n=41)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  <a:tr h="36490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s 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 missing values in any of the datasets were excluded from the analysis.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2144738"/>
                  </a:ext>
                </a:extLst>
              </a:tr>
            </a:tbl>
          </a:graphicData>
        </a:graphic>
      </p:graphicFrame>
      <p:graphicFrame>
        <p:nvGraphicFramePr>
          <p:cNvPr id="20" name="表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3128603"/>
              </p:ext>
            </p:extLst>
          </p:nvPr>
        </p:nvGraphicFramePr>
        <p:xfrm>
          <a:off x="1163818" y="2004632"/>
          <a:ext cx="4626949" cy="65808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626949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2062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erarchical cluster analysis (n=601)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  <a:tr h="35328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uster subjects based on eight sleep parameters.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540998"/>
                  </a:ext>
                </a:extLst>
              </a:tr>
            </a:tbl>
          </a:graphicData>
        </a:graphic>
      </p:graphicFrame>
      <p:cxnSp>
        <p:nvCxnSpPr>
          <p:cNvPr id="5" name="直線矢印コネクタ 4"/>
          <p:cNvCxnSpPr/>
          <p:nvPr/>
        </p:nvCxnSpPr>
        <p:spPr>
          <a:xfrm>
            <a:off x="3477294" y="528034"/>
            <a:ext cx="0" cy="147659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/>
          <p:cNvCxnSpPr/>
          <p:nvPr/>
        </p:nvCxnSpPr>
        <p:spPr>
          <a:xfrm flipH="1">
            <a:off x="3465524" y="939855"/>
            <a:ext cx="42372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2" name="表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6935170"/>
              </p:ext>
            </p:extLst>
          </p:nvPr>
        </p:nvGraphicFramePr>
        <p:xfrm>
          <a:off x="1163818" y="3499419"/>
          <a:ext cx="4626949" cy="9448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626949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2062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e-way ANOVA</a:t>
                      </a:r>
                      <a:r>
                        <a:rPr kumimoji="1" lang="en-US" altLang="ja-JP" sz="14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nonparametric tests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  <a:tr h="35328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 results of the sleep parameters, gut bacteria, physical characteristics and dietary questionnaire were tabulated for each cluster to determine whether they differed between clusters.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540998"/>
                  </a:ext>
                </a:extLst>
              </a:tr>
            </a:tbl>
          </a:graphicData>
        </a:graphic>
      </p:graphicFrame>
      <p:cxnSp>
        <p:nvCxnSpPr>
          <p:cNvPr id="23" name="直線矢印コネクタ 22"/>
          <p:cNvCxnSpPr/>
          <p:nvPr/>
        </p:nvCxnSpPr>
        <p:spPr>
          <a:xfrm>
            <a:off x="3477294" y="2662900"/>
            <a:ext cx="0" cy="82364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4" name="表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7956495"/>
              </p:ext>
            </p:extLst>
          </p:nvPr>
        </p:nvGraphicFramePr>
        <p:xfrm>
          <a:off x="1163818" y="5280818"/>
          <a:ext cx="4626949" cy="76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626949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2062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ltiple regression</a:t>
                      </a:r>
                      <a:r>
                        <a:rPr kumimoji="1" lang="en-US" altLang="ja-JP" sz="14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alysis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  <a:tr h="35328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 relationship between gut bacteria and sleep parameters, which differed significantly between clusters, was examined.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540998"/>
                  </a:ext>
                </a:extLst>
              </a:tr>
            </a:tbl>
          </a:graphicData>
        </a:graphic>
      </p:graphicFrame>
      <p:cxnSp>
        <p:nvCxnSpPr>
          <p:cNvPr id="25" name="直線矢印コネクタ 24"/>
          <p:cNvCxnSpPr/>
          <p:nvPr/>
        </p:nvCxnSpPr>
        <p:spPr>
          <a:xfrm>
            <a:off x="3477294" y="4444299"/>
            <a:ext cx="0" cy="82364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6" name="表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1810593"/>
              </p:ext>
            </p:extLst>
          </p:nvPr>
        </p:nvGraphicFramePr>
        <p:xfrm>
          <a:off x="1163818" y="6889052"/>
          <a:ext cx="4626949" cy="76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626949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2062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usal analysis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  <a:tr h="35328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imate the causal relationship between sleep and gut bacteria and investigate which is the cause and which is the result.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540998"/>
                  </a:ext>
                </a:extLst>
              </a:tr>
            </a:tbl>
          </a:graphicData>
        </a:graphic>
      </p:graphicFrame>
      <p:cxnSp>
        <p:nvCxnSpPr>
          <p:cNvPr id="27" name="直線矢印コネクタ 26"/>
          <p:cNvCxnSpPr/>
          <p:nvPr/>
        </p:nvCxnSpPr>
        <p:spPr>
          <a:xfrm>
            <a:off x="3477294" y="6052533"/>
            <a:ext cx="0" cy="82364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951428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41262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50198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447763" y="8887139"/>
            <a:ext cx="1410237" cy="2568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pPr algn="ctr"/>
            <a:r>
              <a:rPr lang="en-US" altLang="ja-JP" sz="1069" dirty="0" smtClean="0"/>
              <a:t>Supplemental Fig.2</a:t>
            </a:r>
            <a:endParaRPr lang="ja-JP" altLang="en-US" sz="1069" dirty="0"/>
          </a:p>
        </p:txBody>
      </p:sp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8512892"/>
              </p:ext>
            </p:extLst>
          </p:nvPr>
        </p:nvGraphicFramePr>
        <p:xfrm>
          <a:off x="261201" y="147931"/>
          <a:ext cx="3240000" cy="169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1418655"/>
              </p:ext>
            </p:extLst>
          </p:nvPr>
        </p:nvGraphicFramePr>
        <p:xfrm>
          <a:off x="288202" y="2266106"/>
          <a:ext cx="3240000" cy="169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2426987"/>
              </p:ext>
            </p:extLst>
          </p:nvPr>
        </p:nvGraphicFramePr>
        <p:xfrm>
          <a:off x="285016" y="4493604"/>
          <a:ext cx="3240000" cy="169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282169" y="824654"/>
            <a:ext cx="10201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umber of people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All subjects)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1474692" y="1882247"/>
            <a:ext cx="9716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-77787" y="31632"/>
            <a:ext cx="3638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507099" y="170596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0-2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989699" y="170596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0-3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1450829" y="170596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40-4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1908202" y="170596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0-5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2370669" y="170596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60-6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2835466" y="170596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-8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282169" y="2940000"/>
            <a:ext cx="10201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umber of people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Male subject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1474692" y="4002356"/>
            <a:ext cx="9716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-77787" y="2146978"/>
            <a:ext cx="3638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497573" y="3826078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0-2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970647" y="3826078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0-3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1441303" y="3826078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40-4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1912965" y="3826078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0-5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2389721" y="3826078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60-6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2859281" y="3826078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-8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282169" y="5160801"/>
            <a:ext cx="10201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umber of people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Female subject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1474692" y="6223157"/>
            <a:ext cx="9716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-77787" y="4367779"/>
            <a:ext cx="3638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526151" y="604687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0-2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994462" y="604687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0-3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1465118" y="604687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40-4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1932017" y="604687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0-5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2394484" y="604687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60-69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FF6FCB6-BC5B-41D9-88DB-FC3470350385}"/>
              </a:ext>
            </a:extLst>
          </p:cNvPr>
          <p:cNvSpPr txBox="1"/>
          <p:nvPr/>
        </p:nvSpPr>
        <p:spPr>
          <a:xfrm>
            <a:off x="2868807" y="6046879"/>
            <a:ext cx="573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-8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843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162</TotalTime>
  <Words>176</Words>
  <Application>Microsoft Office PowerPoint</Application>
  <PresentationFormat>画面に合わせる (4:3)</PresentationFormat>
  <Paragraphs>4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々木裕之</dc:creator>
  <cp:lastModifiedBy>Sasaki.H/佐々木 裕之</cp:lastModifiedBy>
  <cp:revision>881</cp:revision>
  <cp:lastPrinted>2021-05-28T01:29:58Z</cp:lastPrinted>
  <dcterms:created xsi:type="dcterms:W3CDTF">2018-02-14T07:20:13Z</dcterms:created>
  <dcterms:modified xsi:type="dcterms:W3CDTF">2024-11-27T01:07:46Z</dcterms:modified>
</cp:coreProperties>
</file>